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3" d="100"/>
          <a:sy n="83" d="100"/>
        </p:scale>
        <p:origin x="1387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PAEFTHYMIOU MARIA" userId="9fc4bb3a-9f47-4932-b338-1082eb2e432c" providerId="ADAL" clId="{5B2B6DA9-A8FE-4364-8E8B-5434413A2F21}"/>
    <pc:docChg chg="modSld">
      <pc:chgData name="PAPAEFTHYMIOU MARIA" userId="9fc4bb3a-9f47-4932-b338-1082eb2e432c" providerId="ADAL" clId="{5B2B6DA9-A8FE-4364-8E8B-5434413A2F21}" dt="2024-06-01T02:53:05.273" v="3" actId="20577"/>
      <pc:docMkLst>
        <pc:docMk/>
      </pc:docMkLst>
      <pc:sldChg chg="modSp mod">
        <pc:chgData name="PAPAEFTHYMIOU MARIA" userId="9fc4bb3a-9f47-4932-b338-1082eb2e432c" providerId="ADAL" clId="{5B2B6DA9-A8FE-4364-8E8B-5434413A2F21}" dt="2024-06-01T02:53:05.273" v="3" actId="20577"/>
        <pc:sldMkLst>
          <pc:docMk/>
          <pc:sldMk cId="3198912347" sldId="256"/>
        </pc:sldMkLst>
        <pc:spChg chg="mod">
          <ac:chgData name="PAPAEFTHYMIOU MARIA" userId="9fc4bb3a-9f47-4932-b338-1082eb2e432c" providerId="ADAL" clId="{5B2B6DA9-A8FE-4364-8E8B-5434413A2F21}" dt="2024-06-01T02:53:05.273" v="3" actId="20577"/>
          <ac:spMkLst>
            <pc:docMk/>
            <pc:sldMk cId="3198912347" sldId="256"/>
            <ac:spMk id="220" creationId="{35B94069-87ED-9668-5918-B4804B72FDF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95217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41731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91572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43716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579679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70637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999981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98649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61967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292396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91988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73125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TextBox 223">
            <a:extLst>
              <a:ext uri="{FF2B5EF4-FFF2-40B4-BE49-F238E27FC236}">
                <a16:creationId xmlns:a16="http://schemas.microsoft.com/office/drawing/2014/main" id="{A99DA1B4-CC44-B561-69CC-31B4F13813C2}"/>
              </a:ext>
            </a:extLst>
          </p:cNvPr>
          <p:cNvSpPr txBox="1"/>
          <p:nvPr/>
        </p:nvSpPr>
        <p:spPr>
          <a:xfrm>
            <a:off x="115572" y="124727"/>
            <a:ext cx="8920226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Supplementary </a:t>
            </a:r>
            <a:r>
              <a:rPr kumimoji="0" lang="en-US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Figure S2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: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a-regression analysis of concentration (as effect size) for FRAP, ABTS, ORAC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says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aqueous and hydroalcoholic extracts</a:t>
            </a:r>
            <a:endParaRPr lang="el-GR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l-G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129" name="TextBox 80">
            <a:extLst>
              <a:ext uri="{FF2B5EF4-FFF2-40B4-BE49-F238E27FC236}">
                <a16:creationId xmlns:a16="http://schemas.microsoft.com/office/drawing/2014/main" id="{22B51CF1-0B74-CF58-57F6-A907C84597BF}"/>
              </a:ext>
            </a:extLst>
          </p:cNvPr>
          <p:cNvSpPr txBox="1"/>
          <p:nvPr/>
        </p:nvSpPr>
        <p:spPr>
          <a:xfrm>
            <a:off x="7607859" y="1460242"/>
            <a:ext cx="1211901" cy="298922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just">
              <a:lnSpc>
                <a:spcPts val="1300"/>
              </a:lnSpc>
            </a:pPr>
            <a:r>
              <a:rPr lang="en-US" sz="1000" b="1" i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-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alue=0,489</a:t>
            </a:r>
            <a:r>
              <a:rPr lang="en-US" sz="1000" b="1" i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endParaRPr lang="el-GR" sz="1000" b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1" name="TextBox 80">
            <a:extLst>
              <a:ext uri="{FF2B5EF4-FFF2-40B4-BE49-F238E27FC236}">
                <a16:creationId xmlns:a16="http://schemas.microsoft.com/office/drawing/2014/main" id="{0AD1B2EA-324B-E347-DD2D-D1F80F3AA2C0}"/>
              </a:ext>
            </a:extLst>
          </p:cNvPr>
          <p:cNvSpPr txBox="1"/>
          <p:nvPr/>
        </p:nvSpPr>
        <p:spPr>
          <a:xfrm>
            <a:off x="5075579" y="1470254"/>
            <a:ext cx="1493686" cy="375908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just">
              <a:lnSpc>
                <a:spcPts val="1300"/>
              </a:lnSpc>
            </a:pP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ydroalcoholic</a:t>
            </a:r>
            <a:endParaRPr lang="el-GR" sz="1000" b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223" name="Ομάδα 222">
            <a:extLst>
              <a:ext uri="{FF2B5EF4-FFF2-40B4-BE49-F238E27FC236}">
                <a16:creationId xmlns:a16="http://schemas.microsoft.com/office/drawing/2014/main" id="{E5F792D1-7392-1D6A-EF5B-66CA420A2F65}"/>
              </a:ext>
            </a:extLst>
          </p:cNvPr>
          <p:cNvGrpSpPr/>
          <p:nvPr/>
        </p:nvGrpSpPr>
        <p:grpSpPr>
          <a:xfrm>
            <a:off x="8513" y="1187189"/>
            <a:ext cx="9135487" cy="3366010"/>
            <a:chOff x="36715" y="1199546"/>
            <a:chExt cx="9135487" cy="3366010"/>
          </a:xfrm>
        </p:grpSpPr>
        <p:grpSp>
          <p:nvGrpSpPr>
            <p:cNvPr id="221" name="Ομάδα 220">
              <a:extLst>
                <a:ext uri="{FF2B5EF4-FFF2-40B4-BE49-F238E27FC236}">
                  <a16:creationId xmlns:a16="http://schemas.microsoft.com/office/drawing/2014/main" id="{D09AD706-EE7B-0D3D-3B35-6BDF72678317}"/>
                </a:ext>
              </a:extLst>
            </p:cNvPr>
            <p:cNvGrpSpPr/>
            <p:nvPr/>
          </p:nvGrpSpPr>
          <p:grpSpPr>
            <a:xfrm>
              <a:off x="36715" y="1199546"/>
              <a:ext cx="4543642" cy="3366010"/>
              <a:chOff x="0" y="1133588"/>
              <a:chExt cx="4543642" cy="3366010"/>
            </a:xfrm>
          </p:grpSpPr>
          <p:grpSp>
            <p:nvGrpSpPr>
              <p:cNvPr id="145" name="Ομάδα 144">
                <a:extLst>
                  <a:ext uri="{FF2B5EF4-FFF2-40B4-BE49-F238E27FC236}">
                    <a16:creationId xmlns:a16="http://schemas.microsoft.com/office/drawing/2014/main" id="{7AE8C531-28AA-3763-5D83-DAA15F61A5E6}"/>
                  </a:ext>
                </a:extLst>
              </p:cNvPr>
              <p:cNvGrpSpPr/>
              <p:nvPr/>
            </p:nvGrpSpPr>
            <p:grpSpPr>
              <a:xfrm>
                <a:off x="0" y="1133588"/>
                <a:ext cx="4543642" cy="3366010"/>
                <a:chOff x="5474653" y="1820817"/>
                <a:chExt cx="3921125" cy="2890838"/>
              </a:xfrm>
            </p:grpSpPr>
            <p:grpSp>
              <p:nvGrpSpPr>
                <p:cNvPr id="3" name="Group 4">
                  <a:extLst>
                    <a:ext uri="{FF2B5EF4-FFF2-40B4-BE49-F238E27FC236}">
                      <a16:creationId xmlns:a16="http://schemas.microsoft.com/office/drawing/2014/main" id="{6DF1761F-0282-8713-849C-7E6C93D5B65D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 bwMode="auto">
                <a:xfrm>
                  <a:off x="5474653" y="1820817"/>
                  <a:ext cx="3921125" cy="2890838"/>
                  <a:chOff x="3487" y="1136"/>
                  <a:chExt cx="2470" cy="1821"/>
                </a:xfrm>
              </p:grpSpPr>
              <p:sp>
                <p:nvSpPr>
                  <p:cNvPr id="4" name="AutoShape 3">
                    <a:extLst>
                      <a:ext uri="{FF2B5EF4-FFF2-40B4-BE49-F238E27FC236}">
                        <a16:creationId xmlns:a16="http://schemas.microsoft.com/office/drawing/2014/main" id="{BD67781E-6F98-996F-BA88-B9B24D4895B9}"/>
                      </a:ext>
                    </a:extLst>
                  </p:cNvPr>
                  <p:cNvSpPr>
                    <a:spLocks noChangeAspect="1" noChangeArrowheads="1" noTextEdit="1"/>
                  </p:cNvSpPr>
                  <p:nvPr/>
                </p:nvSpPr>
                <p:spPr bwMode="auto">
                  <a:xfrm>
                    <a:off x="3487" y="1136"/>
                    <a:ext cx="2470" cy="18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5" name="Rectangle 5">
                    <a:extLst>
                      <a:ext uri="{FF2B5EF4-FFF2-40B4-BE49-F238E27FC236}">
                        <a16:creationId xmlns:a16="http://schemas.microsoft.com/office/drawing/2014/main" id="{7F443452-D9AA-7F7A-025B-AB6BB13DDFB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15" y="1162"/>
                    <a:ext cx="2416" cy="1758"/>
                  </a:xfrm>
                  <a:prstGeom prst="rect">
                    <a:avLst/>
                  </a:prstGeom>
                  <a:solidFill>
                    <a:srgbClr val="EAF2F3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6" name="Rectangle 6">
                    <a:extLst>
                      <a:ext uri="{FF2B5EF4-FFF2-40B4-BE49-F238E27FC236}">
                        <a16:creationId xmlns:a16="http://schemas.microsoft.com/office/drawing/2014/main" id="{750A6C36-0232-5F6D-716B-4C88FE2F5ED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16" y="1203"/>
                    <a:ext cx="2412" cy="1754"/>
                  </a:xfrm>
                  <a:prstGeom prst="rect">
                    <a:avLst/>
                  </a:prstGeom>
                  <a:solidFill>
                    <a:srgbClr val="EAF2F3"/>
                  </a:solidFill>
                  <a:ln w="4763">
                    <a:solidFill>
                      <a:srgbClr val="EAF2F3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dirty="0"/>
                  </a:p>
                </p:txBody>
              </p:sp>
              <p:sp>
                <p:nvSpPr>
                  <p:cNvPr id="7" name="Rectangle 7">
                    <a:extLst>
                      <a:ext uri="{FF2B5EF4-FFF2-40B4-BE49-F238E27FC236}">
                        <a16:creationId xmlns:a16="http://schemas.microsoft.com/office/drawing/2014/main" id="{154AA7CB-C41B-BC76-C88A-D8DAC9413B8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755" y="1227"/>
                    <a:ext cx="2111" cy="1453"/>
                  </a:xfrm>
                  <a:prstGeom prst="rect">
                    <a:avLst/>
                  </a:prstGeom>
                  <a:solidFill>
                    <a:srgbClr val="FFFFFF"/>
                  </a:solidFill>
                  <a:ln w="4763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8" name="Line 8">
                    <a:extLst>
                      <a:ext uri="{FF2B5EF4-FFF2-40B4-BE49-F238E27FC236}">
                        <a16:creationId xmlns:a16="http://schemas.microsoft.com/office/drawing/2014/main" id="{9A44D163-6837-A6D7-B920-67E5C7A96FF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55" y="2644"/>
                    <a:ext cx="2113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EAF2F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9" name="Line 9">
                    <a:extLst>
                      <a:ext uri="{FF2B5EF4-FFF2-40B4-BE49-F238E27FC236}">
                        <a16:creationId xmlns:a16="http://schemas.microsoft.com/office/drawing/2014/main" id="{7FF0C4D3-1CE5-84E1-871A-BA212488B5D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55" y="2368"/>
                    <a:ext cx="2113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EAF2F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0" name="Line 10">
                    <a:extLst>
                      <a:ext uri="{FF2B5EF4-FFF2-40B4-BE49-F238E27FC236}">
                        <a16:creationId xmlns:a16="http://schemas.microsoft.com/office/drawing/2014/main" id="{F4588C3A-BE1E-3798-B9C2-ACAB45362DE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55" y="2092"/>
                    <a:ext cx="2113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EAF2F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1" name="Line 11">
                    <a:extLst>
                      <a:ext uri="{FF2B5EF4-FFF2-40B4-BE49-F238E27FC236}">
                        <a16:creationId xmlns:a16="http://schemas.microsoft.com/office/drawing/2014/main" id="{B5961BE1-3061-B981-08D9-A585591CEB9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55" y="1817"/>
                    <a:ext cx="2113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EAF2F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2" name="Line 12">
                    <a:extLst>
                      <a:ext uri="{FF2B5EF4-FFF2-40B4-BE49-F238E27FC236}">
                        <a16:creationId xmlns:a16="http://schemas.microsoft.com/office/drawing/2014/main" id="{23550F52-483A-77F3-10AC-4DD0D03F051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55" y="1541"/>
                    <a:ext cx="2113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EAF2F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3" name="Line 13">
                    <a:extLst>
                      <a:ext uri="{FF2B5EF4-FFF2-40B4-BE49-F238E27FC236}">
                        <a16:creationId xmlns:a16="http://schemas.microsoft.com/office/drawing/2014/main" id="{39E31985-DFF7-2EC3-F4E2-8832C7A7506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55" y="1265"/>
                    <a:ext cx="2113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EAF2F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4" name="Oval 14">
                    <a:extLst>
                      <a:ext uri="{FF2B5EF4-FFF2-40B4-BE49-F238E27FC236}">
                        <a16:creationId xmlns:a16="http://schemas.microsoft.com/office/drawing/2014/main" id="{DF99CAF7-CB84-82C5-2EE2-2AC1FEA17E9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746" y="2475"/>
                    <a:ext cx="94" cy="94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5" name="Line 15">
                    <a:extLst>
                      <a:ext uri="{FF2B5EF4-FFF2-40B4-BE49-F238E27FC236}">
                        <a16:creationId xmlns:a16="http://schemas.microsoft.com/office/drawing/2014/main" id="{A19D49F2-78D5-6AF2-793D-BF6149F713E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516"/>
                    <a:ext cx="1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6" name="Oval 16">
                    <a:extLst>
                      <a:ext uri="{FF2B5EF4-FFF2-40B4-BE49-F238E27FC236}">
                        <a16:creationId xmlns:a16="http://schemas.microsoft.com/office/drawing/2014/main" id="{34127C59-9125-974E-CE57-A50F6136901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78" y="2329"/>
                    <a:ext cx="64" cy="64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7" name="Line 17">
                    <a:extLst>
                      <a:ext uri="{FF2B5EF4-FFF2-40B4-BE49-F238E27FC236}">
                        <a16:creationId xmlns:a16="http://schemas.microsoft.com/office/drawing/2014/main" id="{B5C75710-4E07-7F3D-8B85-BDED1EBE177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811" y="2393"/>
                    <a:ext cx="2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8" name="Oval 18">
                    <a:extLst>
                      <a:ext uri="{FF2B5EF4-FFF2-40B4-BE49-F238E27FC236}">
                        <a16:creationId xmlns:a16="http://schemas.microsoft.com/office/drawing/2014/main" id="{E183A299-1AA6-37BD-55D2-AFD9534A252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781" y="2221"/>
                    <a:ext cx="94" cy="93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9" name="Line 19">
                    <a:extLst>
                      <a:ext uri="{FF2B5EF4-FFF2-40B4-BE49-F238E27FC236}">
                        <a16:creationId xmlns:a16="http://schemas.microsoft.com/office/drawing/2014/main" id="{69B150E5-210C-6F29-51FD-6163D5871ED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830" y="2279"/>
                    <a:ext cx="1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0" name="Oval 20">
                    <a:extLst>
                      <a:ext uri="{FF2B5EF4-FFF2-40B4-BE49-F238E27FC236}">
                        <a16:creationId xmlns:a16="http://schemas.microsoft.com/office/drawing/2014/main" id="{B6DB99EC-FD1C-6988-F1DD-A2D47184F78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98" y="2433"/>
                    <a:ext cx="188" cy="189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1" name="Line 21">
                    <a:extLst>
                      <a:ext uri="{FF2B5EF4-FFF2-40B4-BE49-F238E27FC236}">
                        <a16:creationId xmlns:a16="http://schemas.microsoft.com/office/drawing/2014/main" id="{F5E2E5B0-E572-7222-EAA0-C8815DAFD82B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830" y="2363"/>
                    <a:ext cx="1" cy="1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2" name="Oval 22">
                    <a:extLst>
                      <a:ext uri="{FF2B5EF4-FFF2-40B4-BE49-F238E27FC236}">
                        <a16:creationId xmlns:a16="http://schemas.microsoft.com/office/drawing/2014/main" id="{136DC910-9719-7EE7-A845-CD2C98BB5EA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769" y="2326"/>
                    <a:ext cx="46" cy="45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3" name="Oval 23">
                    <a:extLst>
                      <a:ext uri="{FF2B5EF4-FFF2-40B4-BE49-F238E27FC236}">
                        <a16:creationId xmlns:a16="http://schemas.microsoft.com/office/drawing/2014/main" id="{3B1B5066-51A1-244C-F8A8-3B44234520F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807" y="1761"/>
                    <a:ext cx="7" cy="7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4" name="Oval 24">
                    <a:extLst>
                      <a:ext uri="{FF2B5EF4-FFF2-40B4-BE49-F238E27FC236}">
                        <a16:creationId xmlns:a16="http://schemas.microsoft.com/office/drawing/2014/main" id="{675B1D4D-E071-3FFB-64DF-83D28C8F6E1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37" y="2212"/>
                    <a:ext cx="147" cy="148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5" name="Line 25">
                    <a:extLst>
                      <a:ext uri="{FF2B5EF4-FFF2-40B4-BE49-F238E27FC236}">
                        <a16:creationId xmlns:a16="http://schemas.microsoft.com/office/drawing/2014/main" id="{66B50921-9EF9-514B-B5AF-9A5572EFDA6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811" y="2387"/>
                    <a:ext cx="2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6" name="Line 26">
                    <a:extLst>
                      <a:ext uri="{FF2B5EF4-FFF2-40B4-BE49-F238E27FC236}">
                        <a16:creationId xmlns:a16="http://schemas.microsoft.com/office/drawing/2014/main" id="{AF072190-289A-6ECE-7C20-68CF30894D9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325"/>
                    <a:ext cx="1" cy="1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7" name="Line 27">
                    <a:extLst>
                      <a:ext uri="{FF2B5EF4-FFF2-40B4-BE49-F238E27FC236}">
                        <a16:creationId xmlns:a16="http://schemas.microsoft.com/office/drawing/2014/main" id="{B9A38219-58DE-B676-EF7A-EC30D98D526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505"/>
                    <a:ext cx="1" cy="1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8" name="Line 28">
                    <a:extLst>
                      <a:ext uri="{FF2B5EF4-FFF2-40B4-BE49-F238E27FC236}">
                        <a16:creationId xmlns:a16="http://schemas.microsoft.com/office/drawing/2014/main" id="{5D796FA2-BEA9-955B-4B1F-E22090A1BF2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390"/>
                    <a:ext cx="1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9" name="Oval 29">
                    <a:extLst>
                      <a:ext uri="{FF2B5EF4-FFF2-40B4-BE49-F238E27FC236}">
                        <a16:creationId xmlns:a16="http://schemas.microsoft.com/office/drawing/2014/main" id="{409E4D4E-5179-686B-33B1-E002AA466D3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88" y="2468"/>
                    <a:ext cx="45" cy="45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0" name="Oval 30">
                    <a:extLst>
                      <a:ext uri="{FF2B5EF4-FFF2-40B4-BE49-F238E27FC236}">
                        <a16:creationId xmlns:a16="http://schemas.microsoft.com/office/drawing/2014/main" id="{81A100AF-0F03-FA02-4FA3-E5D071FF6A2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805" y="2109"/>
                    <a:ext cx="9" cy="9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1" name="Oval 31">
                    <a:extLst>
                      <a:ext uri="{FF2B5EF4-FFF2-40B4-BE49-F238E27FC236}">
                        <a16:creationId xmlns:a16="http://schemas.microsoft.com/office/drawing/2014/main" id="{3BE9D766-77BF-F29B-7B45-FD6F7059AD1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79" y="2077"/>
                    <a:ext cx="62" cy="62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2" name="Oval 32">
                    <a:extLst>
                      <a:ext uri="{FF2B5EF4-FFF2-40B4-BE49-F238E27FC236}">
                        <a16:creationId xmlns:a16="http://schemas.microsoft.com/office/drawing/2014/main" id="{4E403CF2-2DE5-02B4-94B6-10420F2CB14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801" y="2060"/>
                    <a:ext cx="19" cy="19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3" name="Oval 33">
                    <a:extLst>
                      <a:ext uri="{FF2B5EF4-FFF2-40B4-BE49-F238E27FC236}">
                        <a16:creationId xmlns:a16="http://schemas.microsoft.com/office/drawing/2014/main" id="{33525090-6D1E-1825-D73F-82307629CC1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51" y="1994"/>
                    <a:ext cx="117" cy="117"/>
                  </a:xfrm>
                  <a:prstGeom prst="ellips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4" name="Line 34">
                    <a:extLst>
                      <a:ext uri="{FF2B5EF4-FFF2-40B4-BE49-F238E27FC236}">
                        <a16:creationId xmlns:a16="http://schemas.microsoft.com/office/drawing/2014/main" id="{DEE84009-0DD5-F40F-B6CE-787EF7D4EA6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830" y="2472"/>
                    <a:ext cx="1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5" name="Line 35">
                    <a:extLst>
                      <a:ext uri="{FF2B5EF4-FFF2-40B4-BE49-F238E27FC236}">
                        <a16:creationId xmlns:a16="http://schemas.microsoft.com/office/drawing/2014/main" id="{FBC1EB5F-666E-9C0B-033B-613D1E5D165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830" y="2469"/>
                    <a:ext cx="1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6" name="Line 36">
                    <a:extLst>
                      <a:ext uri="{FF2B5EF4-FFF2-40B4-BE49-F238E27FC236}">
                        <a16:creationId xmlns:a16="http://schemas.microsoft.com/office/drawing/2014/main" id="{0F923C80-A362-8CDF-A41F-506DC3F72A0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370"/>
                    <a:ext cx="1" cy="1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7" name="Line 37">
                    <a:extLst>
                      <a:ext uri="{FF2B5EF4-FFF2-40B4-BE49-F238E27FC236}">
                        <a16:creationId xmlns:a16="http://schemas.microsoft.com/office/drawing/2014/main" id="{F8D56BB9-CF15-7FDE-CE55-C1A1BF45FBD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383"/>
                    <a:ext cx="1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8" name="Line 38">
                    <a:extLst>
                      <a:ext uri="{FF2B5EF4-FFF2-40B4-BE49-F238E27FC236}">
                        <a16:creationId xmlns:a16="http://schemas.microsoft.com/office/drawing/2014/main" id="{ABB3F08F-3951-A9D5-729E-F6DCBCE8B41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263"/>
                    <a:ext cx="1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9" name="Line 39">
                    <a:extLst>
                      <a:ext uri="{FF2B5EF4-FFF2-40B4-BE49-F238E27FC236}">
                        <a16:creationId xmlns:a16="http://schemas.microsoft.com/office/drawing/2014/main" id="{4AC95A43-B238-197C-FAE1-E5F75E14BD8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301"/>
                    <a:ext cx="1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0" name="Line 40">
                    <a:extLst>
                      <a:ext uri="{FF2B5EF4-FFF2-40B4-BE49-F238E27FC236}">
                        <a16:creationId xmlns:a16="http://schemas.microsoft.com/office/drawing/2014/main" id="{0154C8E1-E0F8-C29A-F2F0-027692B7649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1811"/>
                    <a:ext cx="1" cy="1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1" name="Line 41">
                    <a:extLst>
                      <a:ext uri="{FF2B5EF4-FFF2-40B4-BE49-F238E27FC236}">
                        <a16:creationId xmlns:a16="http://schemas.microsoft.com/office/drawing/2014/main" id="{5F1F5F42-369D-7EA7-A1F7-DF87632B4F9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1370"/>
                    <a:ext cx="1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2" name="Line 42">
                    <a:extLst>
                      <a:ext uri="{FF2B5EF4-FFF2-40B4-BE49-F238E27FC236}">
                        <a16:creationId xmlns:a16="http://schemas.microsoft.com/office/drawing/2014/main" id="{9464D65C-5C5A-779A-DEE8-A3E2DA4C4C3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1954"/>
                    <a:ext cx="1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3" name="Line 43">
                    <a:extLst>
                      <a:ext uri="{FF2B5EF4-FFF2-40B4-BE49-F238E27FC236}">
                        <a16:creationId xmlns:a16="http://schemas.microsoft.com/office/drawing/2014/main" id="{1C195074-94F8-C3CF-1906-06E320BE9EF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125"/>
                    <a:ext cx="1" cy="2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4" name="Line 44">
                    <a:extLst>
                      <a:ext uri="{FF2B5EF4-FFF2-40B4-BE49-F238E27FC236}">
                        <a16:creationId xmlns:a16="http://schemas.microsoft.com/office/drawing/2014/main" id="{7A4340B6-AA3D-8F62-3F10-1DE54FABB31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269"/>
                    <a:ext cx="1" cy="1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5" name="Line 45">
                    <a:extLst>
                      <a:ext uri="{FF2B5EF4-FFF2-40B4-BE49-F238E27FC236}">
                        <a16:creationId xmlns:a16="http://schemas.microsoft.com/office/drawing/2014/main" id="{F578789F-8DBC-35C9-FDEC-753D278BB86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319"/>
                    <a:ext cx="1" cy="1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6" name="Line 46">
                    <a:extLst>
                      <a:ext uri="{FF2B5EF4-FFF2-40B4-BE49-F238E27FC236}">
                        <a16:creationId xmlns:a16="http://schemas.microsoft.com/office/drawing/2014/main" id="{63D9A412-4867-B8B6-F678-02D7DF06511B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562"/>
                    <a:ext cx="1" cy="1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7" name="Line 47">
                    <a:extLst>
                      <a:ext uri="{FF2B5EF4-FFF2-40B4-BE49-F238E27FC236}">
                        <a16:creationId xmlns:a16="http://schemas.microsoft.com/office/drawing/2014/main" id="{C8E3A7B5-0589-D7FA-FA4A-C0DC8E467BF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559"/>
                    <a:ext cx="1" cy="1"/>
                  </a:xfrm>
                  <a:prstGeom prst="line">
                    <a:avLst/>
                  </a:prstGeom>
                  <a:noFill/>
                  <a:ln w="9525">
                    <a:solidFill>
                      <a:srgbClr val="1A476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8" name="Freeform 48">
                    <a:extLst>
                      <a:ext uri="{FF2B5EF4-FFF2-40B4-BE49-F238E27FC236}">
                        <a16:creationId xmlns:a16="http://schemas.microsoft.com/office/drawing/2014/main" id="{68795B9A-2BCB-8527-C845-C363EC66809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93" y="2042"/>
                    <a:ext cx="2037" cy="350"/>
                  </a:xfrm>
                  <a:custGeom>
                    <a:avLst/>
                    <a:gdLst>
                      <a:gd name="T0" fmla="*/ 0 w 1392"/>
                      <a:gd name="T1" fmla="*/ 239 h 239"/>
                      <a:gd name="T2" fmla="*/ 0 w 1392"/>
                      <a:gd name="T3" fmla="*/ 239 h 239"/>
                      <a:gd name="T4" fmla="*/ 0 w 1392"/>
                      <a:gd name="T5" fmla="*/ 239 h 239"/>
                      <a:gd name="T6" fmla="*/ 0 w 1392"/>
                      <a:gd name="T7" fmla="*/ 239 h 239"/>
                      <a:gd name="T8" fmla="*/ 0 w 1392"/>
                      <a:gd name="T9" fmla="*/ 239 h 239"/>
                      <a:gd name="T10" fmla="*/ 0 w 1392"/>
                      <a:gd name="T11" fmla="*/ 239 h 239"/>
                      <a:gd name="T12" fmla="*/ 0 w 1392"/>
                      <a:gd name="T13" fmla="*/ 239 h 239"/>
                      <a:gd name="T14" fmla="*/ 0 w 1392"/>
                      <a:gd name="T15" fmla="*/ 239 h 239"/>
                      <a:gd name="T16" fmla="*/ 0 w 1392"/>
                      <a:gd name="T17" fmla="*/ 239 h 239"/>
                      <a:gd name="T18" fmla="*/ 0 w 1392"/>
                      <a:gd name="T19" fmla="*/ 239 h 239"/>
                      <a:gd name="T20" fmla="*/ 0 w 1392"/>
                      <a:gd name="T21" fmla="*/ 239 h 239"/>
                      <a:gd name="T22" fmla="*/ 0 w 1392"/>
                      <a:gd name="T23" fmla="*/ 239 h 239"/>
                      <a:gd name="T24" fmla="*/ 0 w 1392"/>
                      <a:gd name="T25" fmla="*/ 239 h 239"/>
                      <a:gd name="T26" fmla="*/ 0 w 1392"/>
                      <a:gd name="T27" fmla="*/ 239 h 239"/>
                      <a:gd name="T28" fmla="*/ 0 w 1392"/>
                      <a:gd name="T29" fmla="*/ 239 h 239"/>
                      <a:gd name="T30" fmla="*/ 0 w 1392"/>
                      <a:gd name="T31" fmla="*/ 239 h 239"/>
                      <a:gd name="T32" fmla="*/ 0 w 1392"/>
                      <a:gd name="T33" fmla="*/ 239 h 239"/>
                      <a:gd name="T34" fmla="*/ 0 w 1392"/>
                      <a:gd name="T35" fmla="*/ 239 h 239"/>
                      <a:gd name="T36" fmla="*/ 0 w 1392"/>
                      <a:gd name="T37" fmla="*/ 239 h 239"/>
                      <a:gd name="T38" fmla="*/ 696 w 1392"/>
                      <a:gd name="T39" fmla="*/ 119 h 239"/>
                      <a:gd name="T40" fmla="*/ 696 w 1392"/>
                      <a:gd name="T41" fmla="*/ 119 h 239"/>
                      <a:gd name="T42" fmla="*/ 696 w 1392"/>
                      <a:gd name="T43" fmla="*/ 119 h 239"/>
                      <a:gd name="T44" fmla="*/ 696 w 1392"/>
                      <a:gd name="T45" fmla="*/ 119 h 239"/>
                      <a:gd name="T46" fmla="*/ 696 w 1392"/>
                      <a:gd name="T47" fmla="*/ 119 h 239"/>
                      <a:gd name="T48" fmla="*/ 696 w 1392"/>
                      <a:gd name="T49" fmla="*/ 119 h 239"/>
                      <a:gd name="T50" fmla="*/ 696 w 1392"/>
                      <a:gd name="T51" fmla="*/ 119 h 239"/>
                      <a:gd name="T52" fmla="*/ 696 w 1392"/>
                      <a:gd name="T53" fmla="*/ 119 h 239"/>
                      <a:gd name="T54" fmla="*/ 696 w 1392"/>
                      <a:gd name="T55" fmla="*/ 119 h 239"/>
                      <a:gd name="T56" fmla="*/ 696 w 1392"/>
                      <a:gd name="T57" fmla="*/ 119 h 239"/>
                      <a:gd name="T58" fmla="*/ 1392 w 1392"/>
                      <a:gd name="T59" fmla="*/ 0 h 239"/>
                      <a:gd name="T60" fmla="*/ 1392 w 1392"/>
                      <a:gd name="T61" fmla="*/ 0 h 239"/>
                      <a:gd name="T62" fmla="*/ 1392 w 1392"/>
                      <a:gd name="T63" fmla="*/ 0 h 239"/>
                      <a:gd name="T64" fmla="*/ 1392 w 1392"/>
                      <a:gd name="T65" fmla="*/ 0 h 239"/>
                      <a:gd name="T66" fmla="*/ 1392 w 1392"/>
                      <a:gd name="T67" fmla="*/ 0 h 23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  <a:cxn ang="0">
                        <a:pos x="T34" y="T35"/>
                      </a:cxn>
                      <a:cxn ang="0">
                        <a:pos x="T36" y="T37"/>
                      </a:cxn>
                      <a:cxn ang="0">
                        <a:pos x="T38" y="T39"/>
                      </a:cxn>
                      <a:cxn ang="0">
                        <a:pos x="T40" y="T41"/>
                      </a:cxn>
                      <a:cxn ang="0">
                        <a:pos x="T42" y="T43"/>
                      </a:cxn>
                      <a:cxn ang="0">
                        <a:pos x="T44" y="T45"/>
                      </a:cxn>
                      <a:cxn ang="0">
                        <a:pos x="T46" y="T47"/>
                      </a:cxn>
                      <a:cxn ang="0">
                        <a:pos x="T48" y="T49"/>
                      </a:cxn>
                      <a:cxn ang="0">
                        <a:pos x="T50" y="T51"/>
                      </a:cxn>
                      <a:cxn ang="0">
                        <a:pos x="T52" y="T53"/>
                      </a:cxn>
                      <a:cxn ang="0">
                        <a:pos x="T54" y="T55"/>
                      </a:cxn>
                      <a:cxn ang="0">
                        <a:pos x="T56" y="T57"/>
                      </a:cxn>
                      <a:cxn ang="0">
                        <a:pos x="T58" y="T59"/>
                      </a:cxn>
                      <a:cxn ang="0">
                        <a:pos x="T60" y="T61"/>
                      </a:cxn>
                      <a:cxn ang="0">
                        <a:pos x="T62" y="T63"/>
                      </a:cxn>
                      <a:cxn ang="0">
                        <a:pos x="T64" y="T65"/>
                      </a:cxn>
                      <a:cxn ang="0">
                        <a:pos x="T66" y="T67"/>
                      </a:cxn>
                    </a:cxnLst>
                    <a:rect l="0" t="0" r="r" b="b"/>
                    <a:pathLst>
                      <a:path w="1392" h="239">
                        <a:moveTo>
                          <a:pt x="0" y="239"/>
                        </a:move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0" y="239"/>
                        </a:lnTo>
                        <a:lnTo>
                          <a:pt x="696" y="119"/>
                        </a:lnTo>
                        <a:lnTo>
                          <a:pt x="696" y="119"/>
                        </a:lnTo>
                        <a:lnTo>
                          <a:pt x="696" y="119"/>
                        </a:lnTo>
                        <a:lnTo>
                          <a:pt x="696" y="119"/>
                        </a:lnTo>
                        <a:lnTo>
                          <a:pt x="696" y="119"/>
                        </a:lnTo>
                        <a:lnTo>
                          <a:pt x="696" y="119"/>
                        </a:lnTo>
                        <a:lnTo>
                          <a:pt x="696" y="119"/>
                        </a:lnTo>
                        <a:lnTo>
                          <a:pt x="696" y="119"/>
                        </a:lnTo>
                        <a:lnTo>
                          <a:pt x="696" y="119"/>
                        </a:lnTo>
                        <a:lnTo>
                          <a:pt x="696" y="119"/>
                        </a:lnTo>
                        <a:lnTo>
                          <a:pt x="1392" y="0"/>
                        </a:lnTo>
                        <a:lnTo>
                          <a:pt x="1392" y="0"/>
                        </a:lnTo>
                        <a:lnTo>
                          <a:pt x="1392" y="0"/>
                        </a:lnTo>
                        <a:lnTo>
                          <a:pt x="1392" y="0"/>
                        </a:lnTo>
                        <a:lnTo>
                          <a:pt x="1392" y="0"/>
                        </a:lnTo>
                      </a:path>
                    </a:pathLst>
                  </a:custGeom>
                  <a:noFill/>
                  <a:ln w="9525">
                    <a:solidFill>
                      <a:srgbClr val="90353B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9" name="Line 49">
                    <a:extLst>
                      <a:ext uri="{FF2B5EF4-FFF2-40B4-BE49-F238E27FC236}">
                        <a16:creationId xmlns:a16="http://schemas.microsoft.com/office/drawing/2014/main" id="{A38A38BC-EEEA-DBDE-09B7-F2F88288B35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755" y="1227"/>
                    <a:ext cx="0" cy="1455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50" name="Line 50">
                    <a:extLst>
                      <a:ext uri="{FF2B5EF4-FFF2-40B4-BE49-F238E27FC236}">
                        <a16:creationId xmlns:a16="http://schemas.microsoft.com/office/drawing/2014/main" id="{CB7A53C4-5EC5-904B-5A6C-8DF9E7A53D4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30" y="2644"/>
                    <a:ext cx="25" cy="0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51" name="Rectangle 51">
                    <a:extLst>
                      <a:ext uri="{FF2B5EF4-FFF2-40B4-BE49-F238E27FC236}">
                        <a16:creationId xmlns:a16="http://schemas.microsoft.com/office/drawing/2014/main" id="{7CB7DC19-3D79-7BD0-4B92-CF6609FE8CF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3657" y="2583"/>
                    <a:ext cx="65" cy="8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altLang="el-GR" sz="8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0</a:t>
                    </a:r>
                    <a:endParaRPr kumimoji="0" lang="el-GR" altLang="el-GR" sz="18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52" name="Line 52">
                    <a:extLst>
                      <a:ext uri="{FF2B5EF4-FFF2-40B4-BE49-F238E27FC236}">
                        <a16:creationId xmlns:a16="http://schemas.microsoft.com/office/drawing/2014/main" id="{D46A47EE-8962-69EE-4AE0-2F976ABAD84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30" y="2368"/>
                    <a:ext cx="25" cy="0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53" name="Rectangle 53">
                    <a:extLst>
                      <a:ext uri="{FF2B5EF4-FFF2-40B4-BE49-F238E27FC236}">
                        <a16:creationId xmlns:a16="http://schemas.microsoft.com/office/drawing/2014/main" id="{C25127D0-15C1-26EF-381F-BB1386C1331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3622" y="2306"/>
                    <a:ext cx="136" cy="8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altLang="el-GR" sz="8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500</a:t>
                    </a:r>
                    <a:endParaRPr kumimoji="0" lang="el-GR" altLang="el-GR" sz="18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54" name="Line 54">
                    <a:extLst>
                      <a:ext uri="{FF2B5EF4-FFF2-40B4-BE49-F238E27FC236}">
                        <a16:creationId xmlns:a16="http://schemas.microsoft.com/office/drawing/2014/main" id="{5A910A56-F1AB-CAF8-E8AA-1E332EAD835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30" y="2092"/>
                    <a:ext cx="25" cy="0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55" name="Rectangle 55">
                    <a:extLst>
                      <a:ext uri="{FF2B5EF4-FFF2-40B4-BE49-F238E27FC236}">
                        <a16:creationId xmlns:a16="http://schemas.microsoft.com/office/drawing/2014/main" id="{7A3AC15E-64E1-8E97-B935-1070B12B8E0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3604" y="2029"/>
                    <a:ext cx="171" cy="8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altLang="el-GR" sz="8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1000</a:t>
                    </a:r>
                    <a:endParaRPr kumimoji="0" lang="el-GR" altLang="el-GR" sz="18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56" name="Line 56">
                    <a:extLst>
                      <a:ext uri="{FF2B5EF4-FFF2-40B4-BE49-F238E27FC236}">
                        <a16:creationId xmlns:a16="http://schemas.microsoft.com/office/drawing/2014/main" id="{27A9DCE1-EB80-3425-5A20-9FF234F1743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30" y="1817"/>
                    <a:ext cx="25" cy="0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57" name="Rectangle 57">
                    <a:extLst>
                      <a:ext uri="{FF2B5EF4-FFF2-40B4-BE49-F238E27FC236}">
                        <a16:creationId xmlns:a16="http://schemas.microsoft.com/office/drawing/2014/main" id="{D8127564-771E-D4B2-7C0D-445124109AE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3604" y="1754"/>
                    <a:ext cx="171" cy="8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altLang="el-GR" sz="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1500</a:t>
                    </a:r>
                    <a:endParaRPr kumimoji="0" lang="el-GR" altLang="el-GR" sz="18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58" name="Line 58">
                    <a:extLst>
                      <a:ext uri="{FF2B5EF4-FFF2-40B4-BE49-F238E27FC236}">
                        <a16:creationId xmlns:a16="http://schemas.microsoft.com/office/drawing/2014/main" id="{7AA2AC78-79A0-CAA7-076C-F77E732EF08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30" y="1541"/>
                    <a:ext cx="25" cy="0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59" name="Rectangle 59">
                    <a:extLst>
                      <a:ext uri="{FF2B5EF4-FFF2-40B4-BE49-F238E27FC236}">
                        <a16:creationId xmlns:a16="http://schemas.microsoft.com/office/drawing/2014/main" id="{3C3D2736-3F2B-4C91-0B39-7ECEC1C6285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3604" y="1479"/>
                    <a:ext cx="171" cy="8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altLang="el-GR" sz="8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2000</a:t>
                    </a:r>
                    <a:endParaRPr kumimoji="0" lang="el-GR" altLang="el-GR" sz="18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60" name="Line 60">
                    <a:extLst>
                      <a:ext uri="{FF2B5EF4-FFF2-40B4-BE49-F238E27FC236}">
                        <a16:creationId xmlns:a16="http://schemas.microsoft.com/office/drawing/2014/main" id="{DD37D262-9AAF-281B-6A5C-CD5E58C35E5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30" y="1265"/>
                    <a:ext cx="25" cy="0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61" name="Rectangle 61">
                    <a:extLst>
                      <a:ext uri="{FF2B5EF4-FFF2-40B4-BE49-F238E27FC236}">
                        <a16:creationId xmlns:a16="http://schemas.microsoft.com/office/drawing/2014/main" id="{C1AF98CF-81D0-A6F1-1614-74E53161B32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3604" y="1202"/>
                    <a:ext cx="171" cy="8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altLang="el-GR" sz="8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2500</a:t>
                    </a:r>
                    <a:endParaRPr kumimoji="0" lang="el-GR" altLang="el-GR" sz="18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63" name="Line 63">
                    <a:extLst>
                      <a:ext uri="{FF2B5EF4-FFF2-40B4-BE49-F238E27FC236}">
                        <a16:creationId xmlns:a16="http://schemas.microsoft.com/office/drawing/2014/main" id="{B102081D-D8C6-4B1A-D4FC-8A41A818E8F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55" y="2682"/>
                    <a:ext cx="2113" cy="0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28" name="Line 64">
                    <a:extLst>
                      <a:ext uri="{FF2B5EF4-FFF2-40B4-BE49-F238E27FC236}">
                        <a16:creationId xmlns:a16="http://schemas.microsoft.com/office/drawing/2014/main" id="{D1F1D51E-BBEC-248B-E196-936D3F36594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793" y="2682"/>
                    <a:ext cx="0" cy="25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30" name="Line 66">
                    <a:extLst>
                      <a:ext uri="{FF2B5EF4-FFF2-40B4-BE49-F238E27FC236}">
                        <a16:creationId xmlns:a16="http://schemas.microsoft.com/office/drawing/2014/main" id="{8D9DF128-7136-A598-A4D7-D5BA36AE1B9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302" y="2682"/>
                    <a:ext cx="0" cy="25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32" name="Line 68">
                    <a:extLst>
                      <a:ext uri="{FF2B5EF4-FFF2-40B4-BE49-F238E27FC236}">
                        <a16:creationId xmlns:a16="http://schemas.microsoft.com/office/drawing/2014/main" id="{F627EEE2-30E3-5FB7-6BB1-4BB3EA0C070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811" y="2682"/>
                    <a:ext cx="0" cy="25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34" name="Line 70">
                    <a:extLst>
                      <a:ext uri="{FF2B5EF4-FFF2-40B4-BE49-F238E27FC236}">
                        <a16:creationId xmlns:a16="http://schemas.microsoft.com/office/drawing/2014/main" id="{4298E47C-A647-3399-97CC-80B3FB1D5FF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320" y="2682"/>
                    <a:ext cx="0" cy="25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36" name="Line 72">
                    <a:extLst>
                      <a:ext uri="{FF2B5EF4-FFF2-40B4-BE49-F238E27FC236}">
                        <a16:creationId xmlns:a16="http://schemas.microsoft.com/office/drawing/2014/main" id="{F625F8A0-16D5-DD93-1AE2-5A1FAD1CDA4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830" y="2682"/>
                    <a:ext cx="0" cy="25"/>
                  </a:xfrm>
                  <a:prstGeom prst="line">
                    <a:avLst/>
                  </a:prstGeom>
                  <a:noFill/>
                  <a:ln w="4763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138" name="Rectangle 74">
                    <a:extLst>
                      <a:ext uri="{FF2B5EF4-FFF2-40B4-BE49-F238E27FC236}">
                        <a16:creationId xmlns:a16="http://schemas.microsoft.com/office/drawing/2014/main" id="{468EF31C-B99F-3AC2-8BB1-5DB560C3625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626" y="2788"/>
                    <a:ext cx="470" cy="1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lang="en-US" altLang="el-GR" sz="1600" b="1" dirty="0">
                        <a:solidFill>
                          <a:srgbClr val="000000"/>
                        </a:solidFill>
                        <a:latin typeface="Palatino Linotype" panose="02040502050505030304" pitchFamily="18" charset="0"/>
                      </a:rPr>
                      <a:t>assay</a:t>
                    </a:r>
                    <a:r>
                      <a:rPr kumimoji="0" lang="en-US" altLang="el-GR" sz="16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rPr>
                      <a:t> </a:t>
                    </a:r>
                    <a:r>
                      <a:rPr kumimoji="0" lang="el-GR" altLang="el-GR" sz="16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rPr>
                      <a:t>code</a:t>
                    </a:r>
                    <a:endParaRPr kumimoji="0" lang="el-GR" altLang="el-GR" sz="1600" b="1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Palatino Linotype" panose="02040502050505030304" pitchFamily="18" charset="0"/>
                    </a:endParaRPr>
                  </a:p>
                </p:txBody>
              </p:sp>
            </p:grpSp>
            <p:sp>
              <p:nvSpPr>
                <p:cNvPr id="140" name="Rectangle 65">
                  <a:extLst>
                    <a:ext uri="{FF2B5EF4-FFF2-40B4-BE49-F238E27FC236}">
                      <a16:creationId xmlns:a16="http://schemas.microsoft.com/office/drawing/2014/main" id="{87D426DC-65EC-AF91-2DC3-3D452C2304F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14912" y="4324095"/>
                  <a:ext cx="381385" cy="1956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just" eaLnBrk="0" fontAlgn="base" hangingPunct="0">
                    <a:lnSpc>
                      <a:spcPts val="1300"/>
                    </a:lnSpc>
                  </a:pPr>
                  <a:r>
                    <a:rPr lang="en-US" sz="1000" b="1" kern="1200" dirty="0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FRAP</a:t>
                  </a:r>
                  <a:endParaRPr lang="el-GR" sz="1000" b="1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1" name="Rectangle 69">
                  <a:extLst>
                    <a:ext uri="{FF2B5EF4-FFF2-40B4-BE49-F238E27FC236}">
                      <a16:creationId xmlns:a16="http://schemas.microsoft.com/office/drawing/2014/main" id="{78592093-F4D5-2EA1-8A6B-9DEB85E2F3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487688" y="4337452"/>
                  <a:ext cx="437112" cy="19971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just" eaLnBrk="0" fontAlgn="base" hangingPunct="0">
                    <a:lnSpc>
                      <a:spcPts val="1300"/>
                    </a:lnSpc>
                  </a:pPr>
                  <a:r>
                    <a:rPr lang="en-US" sz="1000" b="1" kern="1200" dirty="0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ORAC</a:t>
                  </a:r>
                  <a:endParaRPr lang="el-GR" sz="1000" b="1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2" name="Rectangle 73">
                  <a:extLst>
                    <a:ext uri="{FF2B5EF4-FFF2-40B4-BE49-F238E27FC236}">
                      <a16:creationId xmlns:a16="http://schemas.microsoft.com/office/drawing/2014/main" id="{26ACC14D-32B8-1AB4-8F55-C99713F6E6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944751" y="4328154"/>
                  <a:ext cx="398498" cy="1915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just" eaLnBrk="0" fontAlgn="base" hangingPunct="0">
                    <a:lnSpc>
                      <a:spcPts val="1300"/>
                    </a:lnSpc>
                  </a:pPr>
                  <a:r>
                    <a:rPr lang="en-US" sz="1000" b="1" kern="1200" dirty="0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BTS</a:t>
                  </a:r>
                  <a:endParaRPr lang="el-GR" sz="1000" b="1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3" name="Rectangle 62">
                  <a:extLst>
                    <a:ext uri="{FF2B5EF4-FFF2-40B4-BE49-F238E27FC236}">
                      <a16:creationId xmlns:a16="http://schemas.microsoft.com/office/drawing/2014/main" id="{68B8D572-16FF-215F-5A04-C8260A01AA8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398604" y="2881965"/>
                  <a:ext cx="608846" cy="2015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just" eaLnBrk="0" fontAlgn="base" hangingPunct="0">
                    <a:lnSpc>
                      <a:spcPts val="1300"/>
                    </a:lnSpc>
                  </a:pPr>
                  <a:r>
                    <a:rPr lang="en-US" sz="1600" b="1" kern="1200" dirty="0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mg</a:t>
                  </a:r>
                  <a:r>
                    <a:rPr lang="en-US" sz="1600" b="1" kern="1200" dirty="0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 /g</a:t>
                  </a:r>
                  <a:endParaRPr lang="el-GR" sz="1600" b="1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4" name="TextBox 80">
                  <a:extLst>
                    <a:ext uri="{FF2B5EF4-FFF2-40B4-BE49-F238E27FC236}">
                      <a16:creationId xmlns:a16="http://schemas.microsoft.com/office/drawing/2014/main" id="{2FEDDB16-8E50-E0DE-FFD4-BA261276308D}"/>
                    </a:ext>
                  </a:extLst>
                </p:cNvPr>
                <p:cNvSpPr txBox="1"/>
                <p:nvPr/>
              </p:nvSpPr>
              <p:spPr>
                <a:xfrm>
                  <a:off x="8142633" y="2090692"/>
                  <a:ext cx="1045860" cy="256724"/>
                </a:xfrm>
                <a:prstGeom prst="rect">
                  <a:avLst/>
                </a:prstGeom>
                <a:noFill/>
              </p:spPr>
              <p:txBody>
                <a:bodyPr wrap="square">
                  <a:noAutofit/>
                </a:bodyPr>
                <a:lstStyle/>
                <a:p>
                  <a:pPr algn="just">
                    <a:lnSpc>
                      <a:spcPts val="1300"/>
                    </a:lnSpc>
                  </a:pPr>
                  <a:r>
                    <a:rPr lang="en-US" sz="1000" b="1" i="1" kern="1200" dirty="0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p-</a:t>
                  </a:r>
                  <a:r>
                    <a:rPr lang="en-US" sz="1000" b="1" kern="1200" dirty="0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value=0.148</a:t>
                  </a:r>
                  <a:r>
                    <a:rPr lang="en-US" sz="1000" b="1" i="1" kern="1200" dirty="0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endParaRPr lang="el-GR" sz="1000" b="1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" name="TextBox 80">
                <a:extLst>
                  <a:ext uri="{FF2B5EF4-FFF2-40B4-BE49-F238E27FC236}">
                    <a16:creationId xmlns:a16="http://schemas.microsoft.com/office/drawing/2014/main" id="{36C3C07C-E0F8-7707-4EBF-1EA6FD02F7C2}"/>
                  </a:ext>
                </a:extLst>
              </p:cNvPr>
              <p:cNvSpPr txBox="1"/>
              <p:nvPr/>
            </p:nvSpPr>
            <p:spPr>
              <a:xfrm>
                <a:off x="806584" y="1421749"/>
                <a:ext cx="1493686" cy="375908"/>
              </a:xfrm>
              <a:prstGeom prst="rect">
                <a:avLst/>
              </a:prstGeom>
              <a:noFill/>
            </p:spPr>
            <p:txBody>
              <a:bodyPr wrap="square">
                <a:noAutofit/>
              </a:bodyPr>
              <a:lstStyle/>
              <a:p>
                <a:pPr algn="just">
                  <a:lnSpc>
                    <a:spcPts val="1300"/>
                  </a:lnSpc>
                </a:pPr>
                <a:r>
                  <a:rPr lang="en-US" sz="1000" b="1" dirty="0">
                    <a:solidFill>
                      <a:srgbClr val="000000"/>
                    </a:solidFill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aqueous</a:t>
                </a:r>
                <a:endParaRPr lang="el-GR" sz="10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22" name="Ομάδα 221">
              <a:extLst>
                <a:ext uri="{FF2B5EF4-FFF2-40B4-BE49-F238E27FC236}">
                  <a16:creationId xmlns:a16="http://schemas.microsoft.com/office/drawing/2014/main" id="{35B1F42D-21B3-B440-9E10-1565F4601E90}"/>
                </a:ext>
              </a:extLst>
            </p:cNvPr>
            <p:cNvGrpSpPr/>
            <p:nvPr/>
          </p:nvGrpSpPr>
          <p:grpSpPr>
            <a:xfrm>
              <a:off x="4460788" y="1199546"/>
              <a:ext cx="4711414" cy="3365461"/>
              <a:chOff x="4535953" y="1153998"/>
              <a:chExt cx="4564063" cy="3349625"/>
            </a:xfrm>
          </p:grpSpPr>
          <p:grpSp>
            <p:nvGrpSpPr>
              <p:cNvPr id="133" name="Group 4">
                <a:extLst>
                  <a:ext uri="{FF2B5EF4-FFF2-40B4-BE49-F238E27FC236}">
                    <a16:creationId xmlns:a16="http://schemas.microsoft.com/office/drawing/2014/main" id="{98463B11-F469-5A07-C3C2-B8A1EC105DB6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4535953" y="1153998"/>
                <a:ext cx="4564063" cy="3349625"/>
                <a:chOff x="2818" y="734"/>
                <a:chExt cx="2875" cy="2110"/>
              </a:xfrm>
            </p:grpSpPr>
            <p:sp>
              <p:nvSpPr>
                <p:cNvPr id="135" name="AutoShape 3">
                  <a:extLst>
                    <a:ext uri="{FF2B5EF4-FFF2-40B4-BE49-F238E27FC236}">
                      <a16:creationId xmlns:a16="http://schemas.microsoft.com/office/drawing/2014/main" id="{4B44E6B4-5705-90DB-0AFB-DEE3D63DA6A2}"/>
                    </a:ext>
                  </a:extLst>
                </p:cNvPr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2818" y="734"/>
                  <a:ext cx="2875" cy="211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7" name="Rectangle 5">
                  <a:extLst>
                    <a:ext uri="{FF2B5EF4-FFF2-40B4-BE49-F238E27FC236}">
                      <a16:creationId xmlns:a16="http://schemas.microsoft.com/office/drawing/2014/main" id="{F8763999-A13B-AB4F-42A9-506DCF1F45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50" y="765"/>
                  <a:ext cx="2812" cy="2047"/>
                </a:xfrm>
                <a:prstGeom prst="rect">
                  <a:avLst/>
                </a:prstGeom>
                <a:solidFill>
                  <a:srgbClr val="EAF2F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39" name="Rectangle 6">
                  <a:extLst>
                    <a:ext uri="{FF2B5EF4-FFF2-40B4-BE49-F238E27FC236}">
                      <a16:creationId xmlns:a16="http://schemas.microsoft.com/office/drawing/2014/main" id="{E4CD91CC-7BDC-5C57-F094-28C630B500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52" y="768"/>
                  <a:ext cx="2807" cy="2042"/>
                </a:xfrm>
                <a:prstGeom prst="rect">
                  <a:avLst/>
                </a:prstGeom>
                <a:solidFill>
                  <a:srgbClr val="EAF2F3"/>
                </a:solidFill>
                <a:ln w="4763">
                  <a:solidFill>
                    <a:srgbClr val="EAF2F3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6" name="Rectangle 7">
                  <a:extLst>
                    <a:ext uri="{FF2B5EF4-FFF2-40B4-BE49-F238E27FC236}">
                      <a16:creationId xmlns:a16="http://schemas.microsoft.com/office/drawing/2014/main" id="{B98CB164-B00C-3B94-C09E-0CF92DC99F9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30" y="840"/>
                  <a:ext cx="2457" cy="1692"/>
                </a:xfrm>
                <a:prstGeom prst="rect">
                  <a:avLst/>
                </a:prstGeom>
                <a:solidFill>
                  <a:srgbClr val="FFFFFF"/>
                </a:solidFill>
                <a:ln w="4763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dirty="0"/>
                </a:p>
              </p:txBody>
            </p:sp>
            <p:sp>
              <p:nvSpPr>
                <p:cNvPr id="147" name="Line 8">
                  <a:extLst>
                    <a:ext uri="{FF2B5EF4-FFF2-40B4-BE49-F238E27FC236}">
                      <a16:creationId xmlns:a16="http://schemas.microsoft.com/office/drawing/2014/main" id="{3DDE406A-0132-E9B9-F9B8-2D2CCB1BE9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30" y="2490"/>
                  <a:ext cx="2459" cy="0"/>
                </a:xfrm>
                <a:prstGeom prst="line">
                  <a:avLst/>
                </a:prstGeom>
                <a:noFill/>
                <a:ln w="11113" cap="flat">
                  <a:solidFill>
                    <a:srgbClr val="EAF2F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8" name="Line 9">
                  <a:extLst>
                    <a:ext uri="{FF2B5EF4-FFF2-40B4-BE49-F238E27FC236}">
                      <a16:creationId xmlns:a16="http://schemas.microsoft.com/office/drawing/2014/main" id="{61A9DF97-11DD-6D3E-4003-D2BF312EC20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30" y="2169"/>
                  <a:ext cx="2459" cy="0"/>
                </a:xfrm>
                <a:prstGeom prst="line">
                  <a:avLst/>
                </a:prstGeom>
                <a:noFill/>
                <a:ln w="11113" cap="flat">
                  <a:solidFill>
                    <a:srgbClr val="EAF2F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49" name="Line 10">
                  <a:extLst>
                    <a:ext uri="{FF2B5EF4-FFF2-40B4-BE49-F238E27FC236}">
                      <a16:creationId xmlns:a16="http://schemas.microsoft.com/office/drawing/2014/main" id="{E18D3FE1-14E4-1212-1193-CC10521EDA6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30" y="1847"/>
                  <a:ext cx="2459" cy="0"/>
                </a:xfrm>
                <a:prstGeom prst="line">
                  <a:avLst/>
                </a:prstGeom>
                <a:noFill/>
                <a:ln w="11113" cap="flat">
                  <a:solidFill>
                    <a:srgbClr val="EAF2F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0" name="Line 11">
                  <a:extLst>
                    <a:ext uri="{FF2B5EF4-FFF2-40B4-BE49-F238E27FC236}">
                      <a16:creationId xmlns:a16="http://schemas.microsoft.com/office/drawing/2014/main" id="{DC20CF2F-D6DA-0E24-2E85-3F54760245A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30" y="1527"/>
                  <a:ext cx="2459" cy="0"/>
                </a:xfrm>
                <a:prstGeom prst="line">
                  <a:avLst/>
                </a:prstGeom>
                <a:noFill/>
                <a:ln w="11113" cap="flat">
                  <a:solidFill>
                    <a:srgbClr val="EAF2F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1" name="Line 12">
                  <a:extLst>
                    <a:ext uri="{FF2B5EF4-FFF2-40B4-BE49-F238E27FC236}">
                      <a16:creationId xmlns:a16="http://schemas.microsoft.com/office/drawing/2014/main" id="{2DFA1D47-8206-9B47-6B2D-668594CE4C1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30" y="1206"/>
                  <a:ext cx="2459" cy="0"/>
                </a:xfrm>
                <a:prstGeom prst="line">
                  <a:avLst/>
                </a:prstGeom>
                <a:noFill/>
                <a:ln w="11113" cap="flat">
                  <a:solidFill>
                    <a:srgbClr val="EAF2F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2" name="Line 13">
                  <a:extLst>
                    <a:ext uri="{FF2B5EF4-FFF2-40B4-BE49-F238E27FC236}">
                      <a16:creationId xmlns:a16="http://schemas.microsoft.com/office/drawing/2014/main" id="{8D5321B6-5074-1CA6-A7D8-153E8B1DA99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30" y="884"/>
                  <a:ext cx="2459" cy="0"/>
                </a:xfrm>
                <a:prstGeom prst="line">
                  <a:avLst/>
                </a:prstGeom>
                <a:noFill/>
                <a:ln w="11113" cap="flat">
                  <a:solidFill>
                    <a:srgbClr val="EAF2F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3" name="Line 14">
                  <a:extLst>
                    <a:ext uri="{FF2B5EF4-FFF2-40B4-BE49-F238E27FC236}">
                      <a16:creationId xmlns:a16="http://schemas.microsoft.com/office/drawing/2014/main" id="{54E10BED-F46D-57C8-6B36-B460FA9AD6A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4" y="2348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4" name="Oval 15">
                  <a:extLst>
                    <a:ext uri="{FF2B5EF4-FFF2-40B4-BE49-F238E27FC236}">
                      <a16:creationId xmlns:a16="http://schemas.microsoft.com/office/drawing/2014/main" id="{413BD65C-2868-7334-462C-18B368B462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33" y="2302"/>
                  <a:ext cx="78" cy="79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5" name="Line 16">
                  <a:extLst>
                    <a:ext uri="{FF2B5EF4-FFF2-40B4-BE49-F238E27FC236}">
                      <a16:creationId xmlns:a16="http://schemas.microsoft.com/office/drawing/2014/main" id="{A0E848EE-73FF-87C8-4C86-ACDA4CE34D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59" y="2162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6" name="Oval 17">
                  <a:extLst>
                    <a:ext uri="{FF2B5EF4-FFF2-40B4-BE49-F238E27FC236}">
                      <a16:creationId xmlns:a16="http://schemas.microsoft.com/office/drawing/2014/main" id="{1E38B451-62AD-91AF-5B57-185224DF50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49" y="2087"/>
                  <a:ext cx="219" cy="220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7" name="Line 18">
                  <a:extLst>
                    <a:ext uri="{FF2B5EF4-FFF2-40B4-BE49-F238E27FC236}">
                      <a16:creationId xmlns:a16="http://schemas.microsoft.com/office/drawing/2014/main" id="{BA2307EE-9FE7-6BAD-96B6-84B85288AF5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45" y="2053"/>
                  <a:ext cx="1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8" name="Oval 19">
                  <a:extLst>
                    <a:ext uri="{FF2B5EF4-FFF2-40B4-BE49-F238E27FC236}">
                      <a16:creationId xmlns:a16="http://schemas.microsoft.com/office/drawing/2014/main" id="{A10DBEFB-8D73-5F89-4D9B-87E31B8D476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41" y="2064"/>
                  <a:ext cx="2" cy="1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59" name="Line 20">
                  <a:extLst>
                    <a:ext uri="{FF2B5EF4-FFF2-40B4-BE49-F238E27FC236}">
                      <a16:creationId xmlns:a16="http://schemas.microsoft.com/office/drawing/2014/main" id="{71CEE2DA-56F0-E969-F2B7-8180BB7B788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4" y="2355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60" name="Oval 21">
                  <a:extLst>
                    <a:ext uri="{FF2B5EF4-FFF2-40B4-BE49-F238E27FC236}">
                      <a16:creationId xmlns:a16="http://schemas.microsoft.com/office/drawing/2014/main" id="{467C15E5-53B0-9382-F4EC-40F0D03A5D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16" y="2133"/>
                  <a:ext cx="54" cy="55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61" name="Line 22">
                  <a:extLst>
                    <a:ext uri="{FF2B5EF4-FFF2-40B4-BE49-F238E27FC236}">
                      <a16:creationId xmlns:a16="http://schemas.microsoft.com/office/drawing/2014/main" id="{FD026C7D-E1F4-26D1-F1B4-8E606F9B52E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4" y="2149"/>
                  <a:ext cx="2" cy="1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62" name="Line 23">
                  <a:extLst>
                    <a:ext uri="{FF2B5EF4-FFF2-40B4-BE49-F238E27FC236}">
                      <a16:creationId xmlns:a16="http://schemas.microsoft.com/office/drawing/2014/main" id="{EE6E310D-2FCD-FA2C-D8DA-2B632DF8567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59" y="1467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63" name="Line 24">
                  <a:extLst>
                    <a:ext uri="{FF2B5EF4-FFF2-40B4-BE49-F238E27FC236}">
                      <a16:creationId xmlns:a16="http://schemas.microsoft.com/office/drawing/2014/main" id="{1EB0F134-4E38-D83B-DDF5-2F995FCCDDB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59" y="2074"/>
                  <a:ext cx="2" cy="1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64" name="Oval 25">
                  <a:extLst>
                    <a:ext uri="{FF2B5EF4-FFF2-40B4-BE49-F238E27FC236}">
                      <a16:creationId xmlns:a16="http://schemas.microsoft.com/office/drawing/2014/main" id="{1ADDE382-A4AB-739A-5EF2-CC1A7647AFD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58" y="2190"/>
                  <a:ext cx="1" cy="1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65" name="Oval 26">
                  <a:extLst>
                    <a:ext uri="{FF2B5EF4-FFF2-40B4-BE49-F238E27FC236}">
                      <a16:creationId xmlns:a16="http://schemas.microsoft.com/office/drawing/2014/main" id="{A66EF947-09AA-6C10-E882-94F749F2916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65" y="2108"/>
                  <a:ext cx="17" cy="17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66" name="Oval 27">
                  <a:extLst>
                    <a:ext uri="{FF2B5EF4-FFF2-40B4-BE49-F238E27FC236}">
                      <a16:creationId xmlns:a16="http://schemas.microsoft.com/office/drawing/2014/main" id="{AA15670F-7D8B-262D-540F-9B3F580A607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1" y="2324"/>
                  <a:ext cx="5" cy="5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67" name="Oval 28">
                  <a:extLst>
                    <a:ext uri="{FF2B5EF4-FFF2-40B4-BE49-F238E27FC236}">
                      <a16:creationId xmlns:a16="http://schemas.microsoft.com/office/drawing/2014/main" id="{09B7B9D0-743E-9987-FFD0-33F06F48DC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69" y="2190"/>
                  <a:ext cx="7" cy="6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68" name="Line 29">
                  <a:extLst>
                    <a:ext uri="{FF2B5EF4-FFF2-40B4-BE49-F238E27FC236}">
                      <a16:creationId xmlns:a16="http://schemas.microsoft.com/office/drawing/2014/main" id="{DDFA4267-A27E-685E-844E-B3789754475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59" y="2312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69" name="Line 30">
                  <a:extLst>
                    <a:ext uri="{FF2B5EF4-FFF2-40B4-BE49-F238E27FC236}">
                      <a16:creationId xmlns:a16="http://schemas.microsoft.com/office/drawing/2014/main" id="{E3997A79-9F55-742B-D54D-EE2C66B585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59" y="1874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70" name="Line 31">
                  <a:extLst>
                    <a:ext uri="{FF2B5EF4-FFF2-40B4-BE49-F238E27FC236}">
                      <a16:creationId xmlns:a16="http://schemas.microsoft.com/office/drawing/2014/main" id="{FFD819A7-0175-5EFD-7EA3-EA99AB6FDB2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59" y="1866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71" name="Line 32">
                  <a:extLst>
                    <a:ext uri="{FF2B5EF4-FFF2-40B4-BE49-F238E27FC236}">
                      <a16:creationId xmlns:a16="http://schemas.microsoft.com/office/drawing/2014/main" id="{49B67B4C-3631-2E5E-9B85-159B9AFD880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59" y="1822"/>
                  <a:ext cx="2" cy="1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72" name="Line 33">
                  <a:extLst>
                    <a:ext uri="{FF2B5EF4-FFF2-40B4-BE49-F238E27FC236}">
                      <a16:creationId xmlns:a16="http://schemas.microsoft.com/office/drawing/2014/main" id="{5BD1E022-755D-2A85-6B80-8FD22B15022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59" y="1803"/>
                  <a:ext cx="2" cy="1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73" name="Line 34">
                  <a:extLst>
                    <a:ext uri="{FF2B5EF4-FFF2-40B4-BE49-F238E27FC236}">
                      <a16:creationId xmlns:a16="http://schemas.microsoft.com/office/drawing/2014/main" id="{A8A004EE-47DF-F435-B8ED-1E0BE5D837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45" y="2290"/>
                  <a:ext cx="1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74" name="Line 35">
                  <a:extLst>
                    <a:ext uri="{FF2B5EF4-FFF2-40B4-BE49-F238E27FC236}">
                      <a16:creationId xmlns:a16="http://schemas.microsoft.com/office/drawing/2014/main" id="{44BED20E-383E-3152-1680-80EA2F390D8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45" y="2287"/>
                  <a:ext cx="1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75" name="Line 36">
                  <a:extLst>
                    <a:ext uri="{FF2B5EF4-FFF2-40B4-BE49-F238E27FC236}">
                      <a16:creationId xmlns:a16="http://schemas.microsoft.com/office/drawing/2014/main" id="{585CCDF9-42D7-D80A-B89F-54FC77F352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4" y="2171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76" name="Line 37">
                  <a:extLst>
                    <a:ext uri="{FF2B5EF4-FFF2-40B4-BE49-F238E27FC236}">
                      <a16:creationId xmlns:a16="http://schemas.microsoft.com/office/drawing/2014/main" id="{511F7959-AE48-7C89-DA3A-582ACC1930C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4" y="2186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77" name="Line 38">
                  <a:extLst>
                    <a:ext uri="{FF2B5EF4-FFF2-40B4-BE49-F238E27FC236}">
                      <a16:creationId xmlns:a16="http://schemas.microsoft.com/office/drawing/2014/main" id="{EB64E487-2A74-FD55-1C38-30E2977A14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4" y="2046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78" name="Line 39">
                  <a:extLst>
                    <a:ext uri="{FF2B5EF4-FFF2-40B4-BE49-F238E27FC236}">
                      <a16:creationId xmlns:a16="http://schemas.microsoft.com/office/drawing/2014/main" id="{56B92BFD-D6D1-8E81-0A70-780073FC5BD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4" y="2091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79" name="Oval 40">
                  <a:extLst>
                    <a:ext uri="{FF2B5EF4-FFF2-40B4-BE49-F238E27FC236}">
                      <a16:creationId xmlns:a16="http://schemas.microsoft.com/office/drawing/2014/main" id="{C77858D2-718D-F566-2936-85FC4386C0D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4" y="1520"/>
                  <a:ext cx="1" cy="1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80" name="Oval 41">
                  <a:extLst>
                    <a:ext uri="{FF2B5EF4-FFF2-40B4-BE49-F238E27FC236}">
                      <a16:creationId xmlns:a16="http://schemas.microsoft.com/office/drawing/2014/main" id="{6C7E9CB8-5B5A-F12B-6B39-41BBDA15E7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4" y="1007"/>
                  <a:ext cx="1" cy="1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81" name="Oval 42">
                  <a:extLst>
                    <a:ext uri="{FF2B5EF4-FFF2-40B4-BE49-F238E27FC236}">
                      <a16:creationId xmlns:a16="http://schemas.microsoft.com/office/drawing/2014/main" id="{1E975B44-A93C-082C-57E6-6564CD270CE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2" y="1685"/>
                  <a:ext cx="1" cy="1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82" name="Oval 43">
                  <a:extLst>
                    <a:ext uri="{FF2B5EF4-FFF2-40B4-BE49-F238E27FC236}">
                      <a16:creationId xmlns:a16="http://schemas.microsoft.com/office/drawing/2014/main" id="{550A1F8F-E374-74A8-EA4D-704A5B070D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2" y="1885"/>
                  <a:ext cx="4" cy="3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83" name="Oval 44">
                  <a:extLst>
                    <a:ext uri="{FF2B5EF4-FFF2-40B4-BE49-F238E27FC236}">
                      <a16:creationId xmlns:a16="http://schemas.microsoft.com/office/drawing/2014/main" id="{383CD809-338B-5853-65ED-6575ECCC4F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1" y="2050"/>
                  <a:ext cx="5" cy="5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84" name="Oval 45">
                  <a:extLst>
                    <a:ext uri="{FF2B5EF4-FFF2-40B4-BE49-F238E27FC236}">
                      <a16:creationId xmlns:a16="http://schemas.microsoft.com/office/drawing/2014/main" id="{469274F4-AEF0-CC00-F7A8-1217683DACA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67" y="2104"/>
                  <a:ext cx="12" cy="12"/>
                </a:xfrm>
                <a:prstGeom prst="ellips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85" name="Line 46">
                  <a:extLst>
                    <a:ext uri="{FF2B5EF4-FFF2-40B4-BE49-F238E27FC236}">
                      <a16:creationId xmlns:a16="http://schemas.microsoft.com/office/drawing/2014/main" id="{12564932-54B9-844C-A34C-D163D740A7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4" y="2394"/>
                  <a:ext cx="2" cy="2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86" name="Line 47">
                  <a:extLst>
                    <a:ext uri="{FF2B5EF4-FFF2-40B4-BE49-F238E27FC236}">
                      <a16:creationId xmlns:a16="http://schemas.microsoft.com/office/drawing/2014/main" id="{0AC505E9-DA1D-FC0F-97AB-0EFDA81A00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4" y="2391"/>
                  <a:ext cx="2" cy="1"/>
                </a:xfrm>
                <a:prstGeom prst="line">
                  <a:avLst/>
                </a:prstGeom>
                <a:noFill/>
                <a:ln w="11113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87" name="Freeform 48">
                  <a:extLst>
                    <a:ext uri="{FF2B5EF4-FFF2-40B4-BE49-F238E27FC236}">
                      <a16:creationId xmlns:a16="http://schemas.microsoft.com/office/drawing/2014/main" id="{ADFC7EBE-DF48-6A9E-57F1-951DA67BD17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174" y="2007"/>
                  <a:ext cx="2371" cy="162"/>
                </a:xfrm>
                <a:custGeom>
                  <a:avLst/>
                  <a:gdLst>
                    <a:gd name="T0" fmla="*/ 0 w 1392"/>
                    <a:gd name="T1" fmla="*/ 0 h 95"/>
                    <a:gd name="T2" fmla="*/ 0 w 1392"/>
                    <a:gd name="T3" fmla="*/ 0 h 95"/>
                    <a:gd name="T4" fmla="*/ 0 w 1392"/>
                    <a:gd name="T5" fmla="*/ 0 h 95"/>
                    <a:gd name="T6" fmla="*/ 0 w 1392"/>
                    <a:gd name="T7" fmla="*/ 0 h 95"/>
                    <a:gd name="T8" fmla="*/ 0 w 1392"/>
                    <a:gd name="T9" fmla="*/ 0 h 95"/>
                    <a:gd name="T10" fmla="*/ 0 w 1392"/>
                    <a:gd name="T11" fmla="*/ 0 h 95"/>
                    <a:gd name="T12" fmla="*/ 0 w 1392"/>
                    <a:gd name="T13" fmla="*/ 0 h 95"/>
                    <a:gd name="T14" fmla="*/ 0 w 1392"/>
                    <a:gd name="T15" fmla="*/ 0 h 95"/>
                    <a:gd name="T16" fmla="*/ 0 w 1392"/>
                    <a:gd name="T17" fmla="*/ 0 h 95"/>
                    <a:gd name="T18" fmla="*/ 0 w 1392"/>
                    <a:gd name="T19" fmla="*/ 0 h 95"/>
                    <a:gd name="T20" fmla="*/ 0 w 1392"/>
                    <a:gd name="T21" fmla="*/ 0 h 95"/>
                    <a:gd name="T22" fmla="*/ 0 w 1392"/>
                    <a:gd name="T23" fmla="*/ 0 h 95"/>
                    <a:gd name="T24" fmla="*/ 0 w 1392"/>
                    <a:gd name="T25" fmla="*/ 0 h 95"/>
                    <a:gd name="T26" fmla="*/ 0 w 1392"/>
                    <a:gd name="T27" fmla="*/ 0 h 95"/>
                    <a:gd name="T28" fmla="*/ 0 w 1392"/>
                    <a:gd name="T29" fmla="*/ 0 h 95"/>
                    <a:gd name="T30" fmla="*/ 0 w 1392"/>
                    <a:gd name="T31" fmla="*/ 0 h 95"/>
                    <a:gd name="T32" fmla="*/ 0 w 1392"/>
                    <a:gd name="T33" fmla="*/ 0 h 95"/>
                    <a:gd name="T34" fmla="*/ 0 w 1392"/>
                    <a:gd name="T35" fmla="*/ 0 h 95"/>
                    <a:gd name="T36" fmla="*/ 0 w 1392"/>
                    <a:gd name="T37" fmla="*/ 0 h 95"/>
                    <a:gd name="T38" fmla="*/ 696 w 1392"/>
                    <a:gd name="T39" fmla="*/ 48 h 95"/>
                    <a:gd name="T40" fmla="*/ 696 w 1392"/>
                    <a:gd name="T41" fmla="*/ 48 h 95"/>
                    <a:gd name="T42" fmla="*/ 696 w 1392"/>
                    <a:gd name="T43" fmla="*/ 48 h 95"/>
                    <a:gd name="T44" fmla="*/ 696 w 1392"/>
                    <a:gd name="T45" fmla="*/ 48 h 95"/>
                    <a:gd name="T46" fmla="*/ 696 w 1392"/>
                    <a:gd name="T47" fmla="*/ 48 h 95"/>
                    <a:gd name="T48" fmla="*/ 696 w 1392"/>
                    <a:gd name="T49" fmla="*/ 48 h 95"/>
                    <a:gd name="T50" fmla="*/ 696 w 1392"/>
                    <a:gd name="T51" fmla="*/ 48 h 95"/>
                    <a:gd name="T52" fmla="*/ 696 w 1392"/>
                    <a:gd name="T53" fmla="*/ 48 h 95"/>
                    <a:gd name="T54" fmla="*/ 696 w 1392"/>
                    <a:gd name="T55" fmla="*/ 48 h 95"/>
                    <a:gd name="T56" fmla="*/ 696 w 1392"/>
                    <a:gd name="T57" fmla="*/ 48 h 95"/>
                    <a:gd name="T58" fmla="*/ 1392 w 1392"/>
                    <a:gd name="T59" fmla="*/ 95 h 95"/>
                    <a:gd name="T60" fmla="*/ 1392 w 1392"/>
                    <a:gd name="T61" fmla="*/ 95 h 95"/>
                    <a:gd name="T62" fmla="*/ 1392 w 1392"/>
                    <a:gd name="T63" fmla="*/ 95 h 95"/>
                    <a:gd name="T64" fmla="*/ 1392 w 1392"/>
                    <a:gd name="T65" fmla="*/ 95 h 95"/>
                    <a:gd name="T66" fmla="*/ 1392 w 1392"/>
                    <a:gd name="T67" fmla="*/ 95 h 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</a:cxnLst>
                  <a:rect l="0" t="0" r="r" b="b"/>
                  <a:pathLst>
                    <a:path w="1392" h="95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696" y="48"/>
                      </a:lnTo>
                      <a:lnTo>
                        <a:pt x="696" y="48"/>
                      </a:lnTo>
                      <a:lnTo>
                        <a:pt x="696" y="48"/>
                      </a:lnTo>
                      <a:lnTo>
                        <a:pt x="696" y="48"/>
                      </a:lnTo>
                      <a:lnTo>
                        <a:pt x="696" y="48"/>
                      </a:lnTo>
                      <a:lnTo>
                        <a:pt x="696" y="48"/>
                      </a:lnTo>
                      <a:lnTo>
                        <a:pt x="696" y="48"/>
                      </a:lnTo>
                      <a:lnTo>
                        <a:pt x="696" y="48"/>
                      </a:lnTo>
                      <a:lnTo>
                        <a:pt x="696" y="48"/>
                      </a:lnTo>
                      <a:lnTo>
                        <a:pt x="696" y="48"/>
                      </a:lnTo>
                      <a:lnTo>
                        <a:pt x="1392" y="95"/>
                      </a:lnTo>
                      <a:lnTo>
                        <a:pt x="1392" y="95"/>
                      </a:lnTo>
                      <a:lnTo>
                        <a:pt x="1392" y="95"/>
                      </a:lnTo>
                      <a:lnTo>
                        <a:pt x="1392" y="95"/>
                      </a:lnTo>
                      <a:lnTo>
                        <a:pt x="1392" y="95"/>
                      </a:lnTo>
                    </a:path>
                  </a:pathLst>
                </a:custGeom>
                <a:noFill/>
                <a:ln w="11113">
                  <a:solidFill>
                    <a:srgbClr val="90353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88" name="Line 49">
                  <a:extLst>
                    <a:ext uri="{FF2B5EF4-FFF2-40B4-BE49-F238E27FC236}">
                      <a16:creationId xmlns:a16="http://schemas.microsoft.com/office/drawing/2014/main" id="{3D9B434B-9FBA-E9F3-180D-2D75666943C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130" y="840"/>
                  <a:ext cx="0" cy="1694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89" name="Line 50">
                  <a:extLst>
                    <a:ext uri="{FF2B5EF4-FFF2-40B4-BE49-F238E27FC236}">
                      <a16:creationId xmlns:a16="http://schemas.microsoft.com/office/drawing/2014/main" id="{1BEC1183-7405-AB5C-37A5-CFDCEDF9C9A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101" y="2490"/>
                  <a:ext cx="29" cy="0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0" name="Rectangle 51">
                  <a:extLst>
                    <a:ext uri="{FF2B5EF4-FFF2-40B4-BE49-F238E27FC236}">
                      <a16:creationId xmlns:a16="http://schemas.microsoft.com/office/drawing/2014/main" id="{8CABD883-6BA3-D373-27E8-BEF56AD01E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016" y="2421"/>
                  <a:ext cx="72" cy="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l-GR" altLang="el-G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1" name="Line 52">
                  <a:extLst>
                    <a:ext uri="{FF2B5EF4-FFF2-40B4-BE49-F238E27FC236}">
                      <a16:creationId xmlns:a16="http://schemas.microsoft.com/office/drawing/2014/main" id="{2578DD74-0818-10EF-9FCB-E4FA1D7453E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101" y="2169"/>
                  <a:ext cx="29" cy="0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2" name="Rectangle 53">
                  <a:extLst>
                    <a:ext uri="{FF2B5EF4-FFF2-40B4-BE49-F238E27FC236}">
                      <a16:creationId xmlns:a16="http://schemas.microsoft.com/office/drawing/2014/main" id="{1D132A48-535D-E815-F9CF-0A06AD2941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976" y="2100"/>
                  <a:ext cx="152" cy="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00</a:t>
                  </a:r>
                  <a:endParaRPr kumimoji="0" lang="el-GR" altLang="el-G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3" name="Line 54">
                  <a:extLst>
                    <a:ext uri="{FF2B5EF4-FFF2-40B4-BE49-F238E27FC236}">
                      <a16:creationId xmlns:a16="http://schemas.microsoft.com/office/drawing/2014/main" id="{B13C357F-F59E-C570-EB3C-33A4C9F95D9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101" y="1847"/>
                  <a:ext cx="29" cy="0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4" name="Rectangle 55">
                  <a:extLst>
                    <a:ext uri="{FF2B5EF4-FFF2-40B4-BE49-F238E27FC236}">
                      <a16:creationId xmlns:a16="http://schemas.microsoft.com/office/drawing/2014/main" id="{7C287C31-B55B-AA87-17FA-A54BDA5A466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956" y="1778"/>
                  <a:ext cx="192" cy="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00</a:t>
                  </a:r>
                  <a:endParaRPr kumimoji="0" lang="el-GR" altLang="el-G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5" name="Line 56">
                  <a:extLst>
                    <a:ext uri="{FF2B5EF4-FFF2-40B4-BE49-F238E27FC236}">
                      <a16:creationId xmlns:a16="http://schemas.microsoft.com/office/drawing/2014/main" id="{2652AEC8-6088-8471-E64B-D11CA261A39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101" y="1527"/>
                  <a:ext cx="29" cy="0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6" name="Rectangle 57">
                  <a:extLst>
                    <a:ext uri="{FF2B5EF4-FFF2-40B4-BE49-F238E27FC236}">
                      <a16:creationId xmlns:a16="http://schemas.microsoft.com/office/drawing/2014/main" id="{5387CB5D-5B3D-5753-669B-898C0C21A4D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956" y="1458"/>
                  <a:ext cx="192" cy="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500</a:t>
                  </a:r>
                  <a:endParaRPr kumimoji="0" lang="el-GR" altLang="el-G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7" name="Line 58">
                  <a:extLst>
                    <a:ext uri="{FF2B5EF4-FFF2-40B4-BE49-F238E27FC236}">
                      <a16:creationId xmlns:a16="http://schemas.microsoft.com/office/drawing/2014/main" id="{7922C867-8F01-1A47-DB7C-2A073EAF327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101" y="1206"/>
                  <a:ext cx="29" cy="0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8" name="Rectangle 59">
                  <a:extLst>
                    <a:ext uri="{FF2B5EF4-FFF2-40B4-BE49-F238E27FC236}">
                      <a16:creationId xmlns:a16="http://schemas.microsoft.com/office/drawing/2014/main" id="{A9A84C35-25C2-96DA-E196-B400823A25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956" y="1138"/>
                  <a:ext cx="192" cy="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000</a:t>
                  </a:r>
                  <a:endParaRPr kumimoji="0" lang="el-GR" altLang="el-G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9" name="Line 60">
                  <a:extLst>
                    <a:ext uri="{FF2B5EF4-FFF2-40B4-BE49-F238E27FC236}">
                      <a16:creationId xmlns:a16="http://schemas.microsoft.com/office/drawing/2014/main" id="{BD286AD6-55C8-7CD9-782D-85C7CD82B3C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101" y="884"/>
                  <a:ext cx="29" cy="0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0" name="Rectangle 61">
                  <a:extLst>
                    <a:ext uri="{FF2B5EF4-FFF2-40B4-BE49-F238E27FC236}">
                      <a16:creationId xmlns:a16="http://schemas.microsoft.com/office/drawing/2014/main" id="{86FCBD1A-6240-276D-FDF4-5EE3A5C889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956" y="816"/>
                  <a:ext cx="192" cy="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500</a:t>
                  </a:r>
                  <a:endParaRPr kumimoji="0" lang="el-GR" altLang="el-G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2" name="Line 63">
                  <a:extLst>
                    <a:ext uri="{FF2B5EF4-FFF2-40B4-BE49-F238E27FC236}">
                      <a16:creationId xmlns:a16="http://schemas.microsoft.com/office/drawing/2014/main" id="{692F6C8F-FAB9-9ACA-8B97-F2FDC9F3F94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30" y="2534"/>
                  <a:ext cx="2459" cy="0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3" name="Line 64">
                  <a:extLst>
                    <a:ext uri="{FF2B5EF4-FFF2-40B4-BE49-F238E27FC236}">
                      <a16:creationId xmlns:a16="http://schemas.microsoft.com/office/drawing/2014/main" id="{304E2F21-801D-CB3A-91AE-9869816FF3C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74" y="2534"/>
                  <a:ext cx="0" cy="29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4" name="Rectangle 65">
                  <a:extLst>
                    <a:ext uri="{FF2B5EF4-FFF2-40B4-BE49-F238E27FC236}">
                      <a16:creationId xmlns:a16="http://schemas.microsoft.com/office/drawing/2014/main" id="{FCE69CCA-B637-DAA9-2D7F-A727EF2C126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55" y="2577"/>
                  <a:ext cx="0" cy="1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l-GR" altLang="el-G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5" name="Line 66">
                  <a:extLst>
                    <a:ext uri="{FF2B5EF4-FFF2-40B4-BE49-F238E27FC236}">
                      <a16:creationId xmlns:a16="http://schemas.microsoft.com/office/drawing/2014/main" id="{2DAC153D-FF07-2D84-9ECD-183BBF03BAF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67" y="2534"/>
                  <a:ext cx="0" cy="29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7" name="Line 68">
                  <a:extLst>
                    <a:ext uri="{FF2B5EF4-FFF2-40B4-BE49-F238E27FC236}">
                      <a16:creationId xmlns:a16="http://schemas.microsoft.com/office/drawing/2014/main" id="{535DE779-AC42-BEEA-D6D1-D8F4D2D4FE6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59" y="2534"/>
                  <a:ext cx="0" cy="29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9" name="Line 70">
                  <a:extLst>
                    <a:ext uri="{FF2B5EF4-FFF2-40B4-BE49-F238E27FC236}">
                      <a16:creationId xmlns:a16="http://schemas.microsoft.com/office/drawing/2014/main" id="{4232AA86-FFE8-9961-5C20-2172F0099A3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52" y="2534"/>
                  <a:ext cx="0" cy="29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1" name="Line 72">
                  <a:extLst>
                    <a:ext uri="{FF2B5EF4-FFF2-40B4-BE49-F238E27FC236}">
                      <a16:creationId xmlns:a16="http://schemas.microsoft.com/office/drawing/2014/main" id="{4D282E21-22B2-4F02-6737-B7CA7CC5B5D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45" y="2534"/>
                  <a:ext cx="0" cy="29"/>
                </a:xfrm>
                <a:prstGeom prst="line">
                  <a:avLst/>
                </a:prstGeom>
                <a:noFill/>
                <a:ln w="47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2" name="Rectangle 73">
                  <a:extLst>
                    <a:ext uri="{FF2B5EF4-FFF2-40B4-BE49-F238E27FC236}">
                      <a16:creationId xmlns:a16="http://schemas.microsoft.com/office/drawing/2014/main" id="{F52A1607-65E3-DAF5-79D2-A4F432C547F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26" y="2577"/>
                  <a:ext cx="0" cy="1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l-GR" altLang="el-G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214" name="Rectangle 65">
                <a:extLst>
                  <a:ext uri="{FF2B5EF4-FFF2-40B4-BE49-F238E27FC236}">
                    <a16:creationId xmlns:a16="http://schemas.microsoft.com/office/drawing/2014/main" id="{6C9BE1D8-641A-299C-29A8-10812D6D3D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62294" y="4051313"/>
                <a:ext cx="441934" cy="22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noAutofit/>
              </a:bodyPr>
              <a:lstStyle/>
              <a:p>
                <a:pPr algn="just" eaLnBrk="0" fontAlgn="base" hangingPunct="0">
                  <a:lnSpc>
                    <a:spcPts val="1300"/>
                  </a:lnSpc>
                </a:pPr>
                <a:r>
                  <a:rPr lang="en-US" sz="1000" b="1" kern="1200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FRAP</a:t>
                </a:r>
                <a:endParaRPr lang="el-GR" sz="10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5" name="Rectangle 69">
                <a:extLst>
                  <a:ext uri="{FF2B5EF4-FFF2-40B4-BE49-F238E27FC236}">
                    <a16:creationId xmlns:a16="http://schemas.microsoft.com/office/drawing/2014/main" id="{DF80BA79-1D6D-155D-31DB-15EE5E2F13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3375" y="4068763"/>
                <a:ext cx="506508" cy="2325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noAutofit/>
              </a:bodyPr>
              <a:lstStyle/>
              <a:p>
                <a:pPr algn="just" eaLnBrk="0" fontAlgn="base" hangingPunct="0">
                  <a:lnSpc>
                    <a:spcPts val="1300"/>
                  </a:lnSpc>
                </a:pPr>
                <a:r>
                  <a:rPr lang="en-US" sz="1000" b="1" kern="1200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ORAC</a:t>
                </a:r>
                <a:endParaRPr lang="el-GR" sz="10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6" name="Rectangle 73">
                <a:extLst>
                  <a:ext uri="{FF2B5EF4-FFF2-40B4-BE49-F238E27FC236}">
                    <a16:creationId xmlns:a16="http://schemas.microsoft.com/office/drawing/2014/main" id="{FCD76221-CFF2-968E-05BA-864756DA0B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31639" y="4115970"/>
                <a:ext cx="461763" cy="2230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noAutofit/>
              </a:bodyPr>
              <a:lstStyle/>
              <a:p>
                <a:pPr algn="just" eaLnBrk="0" fontAlgn="base" hangingPunct="0">
                  <a:lnSpc>
                    <a:spcPts val="1300"/>
                  </a:lnSpc>
                </a:pPr>
                <a:r>
                  <a:rPr lang="en-US" sz="1000" b="1" kern="1200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BTS</a:t>
                </a:r>
                <a:endParaRPr lang="el-GR" sz="10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7" name="Rectangle 74">
                <a:extLst>
                  <a:ext uri="{FF2B5EF4-FFF2-40B4-BE49-F238E27FC236}">
                    <a16:creationId xmlns:a16="http://schemas.microsoft.com/office/drawing/2014/main" id="{38359CA2-0F75-CFA2-6689-26691467A4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73894" y="4183034"/>
                <a:ext cx="864580" cy="2144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l-GR" sz="1600" b="1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assay</a:t>
                </a:r>
                <a:r>
                  <a:rPr kumimoji="0" lang="en-US" altLang="el-GR" sz="16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 </a:t>
                </a:r>
                <a:r>
                  <a:rPr kumimoji="0" lang="el-GR" altLang="el-GR" sz="16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code</a:t>
                </a:r>
                <a:endParaRPr kumimoji="0" lang="el-GR" altLang="el-GR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8" name="Rectangle 62">
                <a:extLst>
                  <a:ext uri="{FF2B5EF4-FFF2-40B4-BE49-F238E27FC236}">
                    <a16:creationId xmlns:a16="http://schemas.microsoft.com/office/drawing/2014/main" id="{A51974EC-61C0-C182-3B11-C4598BA1C2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4373819" y="2405288"/>
                <a:ext cx="708923" cy="2335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noAutofit/>
              </a:bodyPr>
              <a:lstStyle/>
              <a:p>
                <a:pPr algn="just" eaLnBrk="0" fontAlgn="base" hangingPunct="0">
                  <a:lnSpc>
                    <a:spcPts val="1300"/>
                  </a:lnSpc>
                </a:pPr>
                <a:r>
                  <a:rPr lang="en-US" sz="1600" b="1" kern="1200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mg</a:t>
                </a:r>
                <a:r>
                  <a:rPr lang="en-US" sz="1600" b="1" kern="1200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Arial" panose="020B0604020202020204" pitchFamily="34" charset="0"/>
                  </a:rPr>
                  <a:t> /g</a:t>
                </a:r>
                <a:endParaRPr lang="el-GR" sz="16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9" name="TextBox 80">
                <a:extLst>
                  <a:ext uri="{FF2B5EF4-FFF2-40B4-BE49-F238E27FC236}">
                    <a16:creationId xmlns:a16="http://schemas.microsoft.com/office/drawing/2014/main" id="{4A622900-8E40-F764-21CE-9A7FFDA58CB4}"/>
                  </a:ext>
                </a:extLst>
              </p:cNvPr>
              <p:cNvSpPr txBox="1"/>
              <p:nvPr/>
            </p:nvSpPr>
            <p:spPr>
              <a:xfrm>
                <a:off x="5013863" y="1475195"/>
                <a:ext cx="1493686" cy="375908"/>
              </a:xfrm>
              <a:prstGeom prst="rect">
                <a:avLst/>
              </a:prstGeom>
              <a:noFill/>
            </p:spPr>
            <p:txBody>
              <a:bodyPr wrap="square">
                <a:noAutofit/>
              </a:bodyPr>
              <a:lstStyle/>
              <a:p>
                <a:pPr algn="just">
                  <a:lnSpc>
                    <a:spcPts val="1300"/>
                  </a:lnSpc>
                </a:pPr>
                <a:r>
                  <a:rPr lang="en-US" sz="1000" b="1" dirty="0">
                    <a:solidFill>
                      <a:srgbClr val="000000"/>
                    </a:solidFill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hydroalcoholic</a:t>
                </a:r>
                <a:endParaRPr lang="el-GR" sz="10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0" name="TextBox 80">
                <a:extLst>
                  <a:ext uri="{FF2B5EF4-FFF2-40B4-BE49-F238E27FC236}">
                    <a16:creationId xmlns:a16="http://schemas.microsoft.com/office/drawing/2014/main" id="{35B94069-87ED-9668-5918-B4804B72FDF1}"/>
                  </a:ext>
                </a:extLst>
              </p:cNvPr>
              <p:cNvSpPr txBox="1"/>
              <p:nvPr/>
            </p:nvSpPr>
            <p:spPr>
              <a:xfrm>
                <a:off x="7717571" y="1478914"/>
                <a:ext cx="1211901" cy="298922"/>
              </a:xfrm>
              <a:prstGeom prst="rect">
                <a:avLst/>
              </a:prstGeom>
              <a:noFill/>
            </p:spPr>
            <p:txBody>
              <a:bodyPr wrap="square">
                <a:noAutofit/>
              </a:bodyPr>
              <a:lstStyle/>
              <a:p>
                <a:pPr algn="just">
                  <a:lnSpc>
                    <a:spcPts val="1300"/>
                  </a:lnSpc>
                </a:pPr>
                <a:r>
                  <a:rPr lang="en-US" sz="1000" b="1" i="1" kern="1200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p-</a:t>
                </a:r>
                <a:r>
                  <a:rPr lang="en-US" sz="1000" b="1" kern="1200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value=0</a:t>
                </a:r>
                <a:r>
                  <a:rPr lang="en-US" sz="1000" b="1" dirty="0">
                    <a:solidFill>
                      <a:srgbClr val="000000"/>
                    </a:solidFill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.</a:t>
                </a:r>
                <a:r>
                  <a:rPr lang="en-US" sz="1000" b="1" kern="1200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489</a:t>
                </a:r>
                <a:r>
                  <a:rPr lang="en-US" sz="1000" b="1" i="1" kern="1200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 </a:t>
                </a:r>
                <a:endParaRPr lang="el-GR" sz="10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98912347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Θέμα του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</TotalTime>
  <Words>65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Θέμα του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PAPAEFTHYMIOU MARIA</dc:creator>
  <cp:lastModifiedBy>MDPI</cp:lastModifiedBy>
  <cp:revision>3</cp:revision>
  <dcterms:created xsi:type="dcterms:W3CDTF">2024-03-21T05:35:56Z</dcterms:created>
  <dcterms:modified xsi:type="dcterms:W3CDTF">2024-06-04T12:26:44Z</dcterms:modified>
</cp:coreProperties>
</file>